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8628D3-DA3C-47B2-85A6-58768325DE9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99A653-9253-49EE-B48B-80389B9FD4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FD086E-169C-4C97-93A9-7E5696A397A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035CAC-FEB1-409B-A183-F3701340717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A81EA7-C7EF-4F04-97DD-E404636F3B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A5F514-CCEE-49DE-A3BD-95BAAEBAB8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650350-82B0-4145-9B09-BC1FC80FD23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A9E1A6-87F2-4FDE-8763-66A23DA4D1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E20DA4-57EB-4211-B96E-2F0754B6E3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A8AAD3-5589-41F8-8A80-B39F0ACFD3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4E9F50-0280-4555-856C-2922DED0FE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C10C71-5A88-4DC2-9D5A-1DD24B63F3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C6D1D13-27E7-497D-B1D2-6FD9F589091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rcRect l="0" t="66297" r="50061" b="626"/>
          <a:stretch/>
        </p:blipFill>
        <p:spPr>
          <a:xfrm>
            <a:off x="1297080" y="5791320"/>
            <a:ext cx="2349360" cy="2225520"/>
          </a:xfrm>
          <a:prstGeom prst="rect">
            <a:avLst/>
          </a:prstGeom>
          <a:ln w="0">
            <a:noFill/>
          </a:ln>
        </p:spPr>
      </p:pic>
      <p:sp>
        <p:nvSpPr>
          <p:cNvPr id="42" name="TextBox 8"/>
          <p:cNvSpPr/>
          <p:nvPr/>
        </p:nvSpPr>
        <p:spPr>
          <a:xfrm>
            <a:off x="2514600" y="1011240"/>
            <a:ext cx="2209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-reactive prote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Picture 4" descr=""/>
          <p:cNvPicPr/>
          <p:nvPr/>
        </p:nvPicPr>
        <p:blipFill>
          <a:blip r:embed="rId2"/>
          <a:srcRect l="0" t="0" r="0" b="32613"/>
          <a:stretch/>
        </p:blipFill>
        <p:spPr>
          <a:xfrm>
            <a:off x="1241280" y="1322280"/>
            <a:ext cx="4738680" cy="4535640"/>
          </a:xfrm>
          <a:prstGeom prst="rect">
            <a:avLst/>
          </a:prstGeom>
          <a:ln w="0">
            <a:noFill/>
          </a:ln>
        </p:spPr>
      </p:pic>
      <p:sp>
        <p:nvSpPr>
          <p:cNvPr id="44" name="Rectangle 18"/>
          <p:cNvSpPr/>
          <p:nvPr/>
        </p:nvSpPr>
        <p:spPr>
          <a:xfrm>
            <a:off x="2654280" y="7931160"/>
            <a:ext cx="304920" cy="763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19"/>
          <p:cNvSpPr/>
          <p:nvPr/>
        </p:nvSpPr>
        <p:spPr>
          <a:xfrm rot="16200000">
            <a:off x="778680" y="2349000"/>
            <a:ext cx="1063080" cy="185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C-reactive protein (mg/l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20"/>
          <p:cNvSpPr/>
          <p:nvPr/>
        </p:nvSpPr>
        <p:spPr>
          <a:xfrm rot="16200000">
            <a:off x="895320" y="4539960"/>
            <a:ext cx="833040" cy="185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C-reactive protei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21"/>
          <p:cNvSpPr/>
          <p:nvPr/>
        </p:nvSpPr>
        <p:spPr>
          <a:xfrm rot="16200000">
            <a:off x="893520" y="6748200"/>
            <a:ext cx="833040" cy="185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C-reactive protei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22"/>
          <p:cNvSpPr/>
          <p:nvPr/>
        </p:nvSpPr>
        <p:spPr>
          <a:xfrm>
            <a:off x="3591000" y="2286000"/>
            <a:ext cx="75960" cy="22860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24"/>
          <p:cNvSpPr/>
          <p:nvPr/>
        </p:nvSpPr>
        <p:spPr>
          <a:xfrm>
            <a:off x="3602160" y="4491000"/>
            <a:ext cx="75960" cy="22860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25"/>
          <p:cNvSpPr/>
          <p:nvPr/>
        </p:nvSpPr>
        <p:spPr>
          <a:xfrm rot="16200000">
            <a:off x="3206520" y="2340000"/>
            <a:ext cx="833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C-reactive protei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26"/>
          <p:cNvSpPr/>
          <p:nvPr/>
        </p:nvSpPr>
        <p:spPr>
          <a:xfrm rot="16200000">
            <a:off x="3213000" y="4547880"/>
            <a:ext cx="833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C-reactive protei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TextBox 12"/>
          <p:cNvSpPr/>
          <p:nvPr/>
        </p:nvSpPr>
        <p:spPr>
          <a:xfrm rot="16200000">
            <a:off x="868320" y="6568920"/>
            <a:ext cx="794880" cy="185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TNF-</a:t>
            </a:r>
            <a:r>
              <a:rPr b="1" lang="el-GR" sz="6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 receptor 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Picture 2" descr=""/>
          <p:cNvPicPr/>
          <p:nvPr/>
        </p:nvPicPr>
        <p:blipFill>
          <a:blip r:embed="rId1"/>
          <a:srcRect l="2234" t="66274" r="50061" b="310"/>
          <a:stretch/>
        </p:blipFill>
        <p:spPr>
          <a:xfrm>
            <a:off x="1339920" y="5715000"/>
            <a:ext cx="2244600" cy="224784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3" descr=""/>
          <p:cNvPicPr/>
          <p:nvPr/>
        </p:nvPicPr>
        <p:blipFill>
          <a:blip r:embed="rId2"/>
          <a:srcRect l="0" t="0" r="0" b="32734"/>
          <a:stretch/>
        </p:blipFill>
        <p:spPr>
          <a:xfrm>
            <a:off x="1149480" y="1295280"/>
            <a:ext cx="4754520" cy="4510080"/>
          </a:xfrm>
          <a:prstGeom prst="rect">
            <a:avLst/>
          </a:prstGeom>
          <a:ln w="0">
            <a:noFill/>
          </a:ln>
        </p:spPr>
      </p:pic>
      <p:sp>
        <p:nvSpPr>
          <p:cNvPr id="55" name="Rectangle 7"/>
          <p:cNvSpPr/>
          <p:nvPr/>
        </p:nvSpPr>
        <p:spPr>
          <a:xfrm>
            <a:off x="2602080" y="7864560"/>
            <a:ext cx="304560" cy="7596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8"/>
          <p:cNvSpPr/>
          <p:nvPr/>
        </p:nvSpPr>
        <p:spPr>
          <a:xfrm>
            <a:off x="1371600" y="990720"/>
            <a:ext cx="4489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Tumor necrosis factor-alpha receptor 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9"/>
          <p:cNvSpPr/>
          <p:nvPr/>
        </p:nvSpPr>
        <p:spPr>
          <a:xfrm rot="16200000">
            <a:off x="718560" y="2176560"/>
            <a:ext cx="1072080" cy="185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TNF-</a:t>
            </a:r>
            <a:r>
              <a:rPr b="1" lang="el-GR" sz="6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 receptor 1 (pg/ml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11"/>
          <p:cNvSpPr/>
          <p:nvPr/>
        </p:nvSpPr>
        <p:spPr>
          <a:xfrm rot="16200000">
            <a:off x="861840" y="4352760"/>
            <a:ext cx="794880" cy="185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TNF-</a:t>
            </a:r>
            <a:r>
              <a:rPr b="1" lang="el-GR" sz="6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 receptor 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13"/>
          <p:cNvSpPr/>
          <p:nvPr/>
        </p:nvSpPr>
        <p:spPr>
          <a:xfrm rot="16200000">
            <a:off x="3395520" y="2278080"/>
            <a:ext cx="380880" cy="1141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14"/>
          <p:cNvSpPr/>
          <p:nvPr/>
        </p:nvSpPr>
        <p:spPr>
          <a:xfrm rot="16200000">
            <a:off x="3387600" y="4476600"/>
            <a:ext cx="380880" cy="1141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10"/>
          <p:cNvSpPr/>
          <p:nvPr/>
        </p:nvSpPr>
        <p:spPr>
          <a:xfrm rot="16200000">
            <a:off x="3166920" y="2135160"/>
            <a:ext cx="8017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TNF-</a:t>
            </a:r>
            <a:r>
              <a:rPr b="1" lang="el-GR" sz="6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 receptor 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15"/>
          <p:cNvSpPr/>
          <p:nvPr/>
        </p:nvSpPr>
        <p:spPr>
          <a:xfrm rot="16200000">
            <a:off x="3172320" y="4366440"/>
            <a:ext cx="8035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TNF-</a:t>
            </a:r>
            <a:r>
              <a:rPr b="1" lang="el-GR" sz="6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 receptor 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Picture 2" descr=""/>
          <p:cNvPicPr/>
          <p:nvPr/>
        </p:nvPicPr>
        <p:blipFill>
          <a:blip r:embed="rId1"/>
          <a:srcRect l="2232" t="66274" r="50011" b="310"/>
          <a:stretch/>
        </p:blipFill>
        <p:spPr>
          <a:xfrm>
            <a:off x="1319040" y="5648400"/>
            <a:ext cx="2249640" cy="2247840"/>
          </a:xfrm>
          <a:prstGeom prst="rect">
            <a:avLst/>
          </a:prstGeom>
          <a:ln w="0">
            <a:noFill/>
          </a:ln>
        </p:spPr>
      </p:pic>
      <p:sp>
        <p:nvSpPr>
          <p:cNvPr id="64" name="Rectangle 7"/>
          <p:cNvSpPr/>
          <p:nvPr/>
        </p:nvSpPr>
        <p:spPr>
          <a:xfrm>
            <a:off x="2589120" y="7796160"/>
            <a:ext cx="304920" cy="763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8"/>
          <p:cNvSpPr/>
          <p:nvPr/>
        </p:nvSpPr>
        <p:spPr>
          <a:xfrm>
            <a:off x="2514600" y="990720"/>
            <a:ext cx="1828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oluble CD16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Picture 2" descr=""/>
          <p:cNvPicPr/>
          <p:nvPr/>
        </p:nvPicPr>
        <p:blipFill>
          <a:blip r:embed="rId2"/>
          <a:srcRect l="0" t="0" r="0" b="34267"/>
          <a:stretch/>
        </p:blipFill>
        <p:spPr>
          <a:xfrm>
            <a:off x="1162080" y="1295280"/>
            <a:ext cx="4714920" cy="4386240"/>
          </a:xfrm>
          <a:prstGeom prst="rect">
            <a:avLst/>
          </a:prstGeom>
          <a:ln w="0">
            <a:noFill/>
          </a:ln>
        </p:spPr>
      </p:pic>
      <p:sp>
        <p:nvSpPr>
          <p:cNvPr id="67" name="Rectangle 17"/>
          <p:cNvSpPr/>
          <p:nvPr/>
        </p:nvSpPr>
        <p:spPr>
          <a:xfrm>
            <a:off x="2583000" y="7792920"/>
            <a:ext cx="304560" cy="763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18"/>
          <p:cNvSpPr/>
          <p:nvPr/>
        </p:nvSpPr>
        <p:spPr>
          <a:xfrm rot="16200000">
            <a:off x="736920" y="2136600"/>
            <a:ext cx="994680" cy="185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Soluble CD163 (ng/ml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19"/>
          <p:cNvSpPr/>
          <p:nvPr/>
        </p:nvSpPr>
        <p:spPr>
          <a:xfrm rot="16200000">
            <a:off x="867600" y="4341600"/>
            <a:ext cx="717120" cy="185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Soluble CD16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20"/>
          <p:cNvSpPr/>
          <p:nvPr/>
        </p:nvSpPr>
        <p:spPr>
          <a:xfrm rot="16200000">
            <a:off x="867600" y="6547320"/>
            <a:ext cx="717120" cy="185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Soluble CD16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21"/>
          <p:cNvSpPr/>
          <p:nvPr/>
        </p:nvSpPr>
        <p:spPr>
          <a:xfrm>
            <a:off x="3505320" y="2133720"/>
            <a:ext cx="75960" cy="30456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22"/>
          <p:cNvSpPr/>
          <p:nvPr/>
        </p:nvSpPr>
        <p:spPr>
          <a:xfrm rot="16200000">
            <a:off x="3183480" y="2127240"/>
            <a:ext cx="7171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Soluble CD16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24"/>
          <p:cNvSpPr/>
          <p:nvPr/>
        </p:nvSpPr>
        <p:spPr>
          <a:xfrm>
            <a:off x="3514680" y="4343400"/>
            <a:ext cx="76320" cy="3049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23"/>
          <p:cNvSpPr/>
          <p:nvPr/>
        </p:nvSpPr>
        <p:spPr>
          <a:xfrm rot="16200000">
            <a:off x="3188520" y="4347360"/>
            <a:ext cx="7171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Soluble CD16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8-18T15:07:27Z</dcterms:created>
  <dc:creator>koethejr</dc:creator>
  <dc:description/>
  <dc:language>en-US</dc:language>
  <cp:lastModifiedBy>koethejr</cp:lastModifiedBy>
  <dcterms:modified xsi:type="dcterms:W3CDTF">2014-08-26T14:10:51Z</dcterms:modified>
  <cp:revision>21</cp:revision>
  <dc:subject/>
  <dc:title>Slide 1</dc:title>
</cp:coreProperties>
</file>